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ECE055-FA91-48F0-9AA8-4C93EC6DEA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E3A8D5-CC16-433B-8988-277DB9D210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EFC6CF-DE30-44BC-BFCA-B3133E46AD4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68463B-7667-4020-9A07-234020F5D2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DC9E61-E787-4441-B37C-537B45B7F7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3426F6-C6E3-4EDA-9541-17FC6242D6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16A5AB-DB31-4F6A-B1B1-A71302DA0F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2AD3EE-C4D9-43CB-841A-E9594E3983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628827-9888-4D07-A917-0FD8331005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617438-17B3-40F2-8312-DE1C0BA0A1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E3EAB6-25D0-4AB6-9920-D85ECD5FCC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4A08F7-A56B-4EBB-93AD-9773FC4F3E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19800"/>
            <a:ext cx="217152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AFC3D1-F686-4BE2-910F-8D8B918F4D6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mailto:p.deberardinis@ibp.cnr.it" TargetMode="External"/><Relationship Id="rId2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89000" y="200160"/>
            <a:ext cx="6048360" cy="341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</a:rPr>
              <a:t>Supplementary Figures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Vectorized delivery of alpha-GalactosylCeramide and tumor antigen on filamentous bacteriophage fd induces protective immunity by enhancing tumor-specific T cell respons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Rossella Sartorius</a:t>
            </a:r>
            <a:r>
              <a:rPr b="0" lang="it-IT" sz="12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*, Luciana D’Apice</a:t>
            </a:r>
            <a:r>
              <a:rPr b="0" lang="it-IT" sz="12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, Pasquale Barba</a:t>
            </a:r>
            <a:r>
              <a:rPr b="0" lang="it-IT" sz="1200" spc="-1" strike="noStrike" baseline="30000">
                <a:solidFill>
                  <a:srgbClr val="000000"/>
                </a:solidFill>
                <a:latin typeface="Times New Roman"/>
              </a:rPr>
              <a:t>2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, Deborah Cipria</a:t>
            </a:r>
            <a:r>
              <a:rPr b="0" lang="it-IT" sz="12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, Laura Grauso</a:t>
            </a:r>
            <a:r>
              <a:rPr b="0" lang="it-IT" sz="1200" spc="-1" strike="noStrike" baseline="30000">
                <a:solidFill>
                  <a:srgbClr val="000000"/>
                </a:solidFill>
                <a:latin typeface="Times New Roman"/>
              </a:rPr>
              <a:t>3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, Adele Cutignano</a:t>
            </a:r>
            <a:r>
              <a:rPr b="0" lang="it-IT" sz="1200" spc="-1" strike="noStrike" baseline="30000">
                <a:solidFill>
                  <a:srgbClr val="000000"/>
                </a:solidFill>
                <a:latin typeface="Times New Roman"/>
              </a:rPr>
              <a:t>3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, Piergiuseppe De Berardinis</a:t>
            </a:r>
            <a:r>
              <a:rPr b="0" lang="it-IT" sz="12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MS Mincho"/>
              </a:rPr>
              <a:t>1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Institute of Protein Biochemistry, CNR, Naples, Ital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MS Mincho"/>
              </a:rPr>
              <a:t>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Institute of Genetics and Biophysics "A. Buzzati Traverso", Naples, Ital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MS Mincho"/>
              </a:rPr>
              <a:t>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Institute of Biomolecular Chemistry (ICB), CNR, Pozzuoli (NA), Ital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*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Correspondence: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Rossella Sartoriu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 u="sng">
                <a:solidFill>
                  <a:srgbClr val="009999"/>
                </a:solidFill>
                <a:uFillTx/>
                <a:latin typeface="Times New Roman"/>
                <a:hlinkClick r:id="rId1"/>
              </a:rPr>
              <a:t>r.sartorius@ibp.cnr.it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/>
          </p:nvPr>
        </p:nvSpPr>
        <p:spPr>
          <a:xfrm>
            <a:off x="907560" y="3751200"/>
            <a:ext cx="5040360" cy="696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1000"/>
          </a:bodyPr>
          <a:p>
            <a:pPr indent="0" algn="just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Figure S1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 Individual tumour growth curves for fd/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-GalCer treated mic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 algn="just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Individual tumour growth curves for mice (n=5) injected subcutaneously with B16-OVA melanoma cell line and intratumorally treated twice with fd/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-GalCer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1773360" y="1065240"/>
            <a:ext cx="3384360" cy="2666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333360" y="4160880"/>
            <a:ext cx="6120000" cy="105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Figure S2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 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Percentage of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OVA</a:t>
            </a:r>
            <a:r>
              <a:rPr b="1" lang="en-GB" sz="1200" spc="-1" strike="noStrike" baseline="-25000">
                <a:solidFill>
                  <a:srgbClr val="000000"/>
                </a:solidFill>
                <a:latin typeface="Times New Roman"/>
                <a:ea typeface="MS Mincho"/>
              </a:rPr>
              <a:t>254-267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CD8</a:t>
            </a:r>
            <a:r>
              <a:rPr b="1" lang="en-GB" sz="1200" spc="-1" strike="noStrike" baseline="30000">
                <a:solidFill>
                  <a:srgbClr val="000000"/>
                </a:solidFill>
                <a:latin typeface="Times New Roman"/>
                <a:ea typeface="MS Mincho"/>
              </a:rPr>
              <a:t>+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 T cell in spleen of B16-OVA-engrafted mice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Groups of mice (n=3) engrafted with B16-OVA cells and treated intratumorally twice with fdOVA,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-GalCer or fdOVA/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-GalCer were sacrificed at day 12 post vaccination and percentages of CD8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MS Mincho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OVA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MS Mincho"/>
              </a:rPr>
              <a:t>254-267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specific lymphocytes in the spleens were evaluated. Mean percentages of CD8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MS Mincho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 gated /H2Kb-SIINFEKL dextrame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MS Mincho"/>
              </a:rPr>
              <a:t>+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cells are reported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1625760" y="1065240"/>
            <a:ext cx="3605040" cy="3063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4-16T15:04:13Z</dcterms:created>
  <dc:creator>Lab 17-3</dc:creator>
  <dc:description/>
  <dc:language>en-US</dc:language>
  <cp:lastModifiedBy>Lab 17-3</cp:lastModifiedBy>
  <dcterms:modified xsi:type="dcterms:W3CDTF">2018-06-21T10:20:07Z</dcterms:modified>
  <cp:revision>33</cp:revision>
  <dc:subject/>
  <dc:title>Diapositiva 1</dc:title>
</cp:coreProperties>
</file>